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_rels/slide8.xml.rels" ContentType="application/vnd.openxmlformats-package.relationships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69E52C-D470-42FD-A13F-E8D088D411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EA5AE5-AF0B-456E-B8E2-5258B88F12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A8CBE8-44DD-43F5-9519-4003562945B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466A24-EC2B-4CAB-978D-A05E6CE99D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E58F5F-358A-488A-8CE4-A821A4102B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9B8950-999D-4E1B-BF09-EF2086A971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CE6C61-9614-4F36-B0DA-28FF443CAA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5CFF9E-893D-4E99-B1B6-A6ABD17408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8C10B7-88DB-4C6A-B033-6A1B53D173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50BA30-A5A0-4A6E-9640-5759B7A5F5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741F2B-846D-46B4-8342-DADCBAB24E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878607-7E8D-424F-BCB5-EC9955E124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5B1FC7-44B2-46E6-8019-151049DEC2C5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3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3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69560" cy="6116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69560" cy="611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69560" cy="611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69560" cy="611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69560" cy="611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69560" cy="611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69560" cy="611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69560" cy="611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69560" cy="611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55160" cy="611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69560" cy="611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69560" cy="611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69560" cy="611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69560" cy="611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69560" cy="611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69560" cy="611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06T08:06:35Z</dcterms:created>
  <dc:creator>Administrator</dc:creator>
  <dc:description/>
  <dc:language>en-US</dc:language>
  <cp:lastModifiedBy>Administrator</cp:lastModifiedBy>
  <dcterms:modified xsi:type="dcterms:W3CDTF">2013-09-06T08:28:20Z</dcterms:modified>
  <cp:revision>1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